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3" r:id="rId5"/>
    <p:sldId id="260" r:id="rId6"/>
    <p:sldId id="264" r:id="rId7"/>
    <p:sldId id="265" r:id="rId8"/>
    <p:sldId id="266" r:id="rId9"/>
    <p:sldId id="262" r:id="rId10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80" d="100"/>
          <a:sy n="80" d="100"/>
        </p:scale>
        <p:origin x="77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701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7942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647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042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3459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776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879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8380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6770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494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465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05ED8B-EA8D-4723-8A30-4AE79DEE2119}" type="datetimeFigureOut">
              <a:rPr lang="en-US" smtClean="0"/>
              <a:t>2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7FB92-3CAA-4759-AFDC-8977C75146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2734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5.png"/><Relationship Id="rId18" Type="http://schemas.openxmlformats.org/officeDocument/2006/relationships/image" Target="../media/image20.png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12" Type="http://schemas.openxmlformats.org/officeDocument/2006/relationships/image" Target="../media/image14.png"/><Relationship Id="rId17" Type="http://schemas.openxmlformats.org/officeDocument/2006/relationships/image" Target="../media/image19.png"/><Relationship Id="rId2" Type="http://schemas.openxmlformats.org/officeDocument/2006/relationships/image" Target="../media/image4.png"/><Relationship Id="rId16" Type="http://schemas.openxmlformats.org/officeDocument/2006/relationships/image" Target="../media/image18.png"/><Relationship Id="rId20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11" Type="http://schemas.openxmlformats.org/officeDocument/2006/relationships/image" Target="../media/image13.png"/><Relationship Id="rId5" Type="http://schemas.openxmlformats.org/officeDocument/2006/relationships/image" Target="../media/image7.png"/><Relationship Id="rId15" Type="http://schemas.openxmlformats.org/officeDocument/2006/relationships/image" Target="../media/image17.png"/><Relationship Id="rId10" Type="http://schemas.openxmlformats.org/officeDocument/2006/relationships/image" Target="../media/image12.png"/><Relationship Id="rId19" Type="http://schemas.openxmlformats.org/officeDocument/2006/relationships/image" Target="../media/image21.png"/><Relationship Id="rId4" Type="http://schemas.openxmlformats.org/officeDocument/2006/relationships/image" Target="../media/image6.png"/><Relationship Id="rId9" Type="http://schemas.openxmlformats.org/officeDocument/2006/relationships/image" Target="../media/image11.png"/><Relationship Id="rId14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13" Type="http://schemas.openxmlformats.org/officeDocument/2006/relationships/image" Target="../media/image32.emf"/><Relationship Id="rId3" Type="http://schemas.openxmlformats.org/officeDocument/2006/relationships/image" Target="../media/image24.emf"/><Relationship Id="rId7" Type="http://schemas.openxmlformats.org/officeDocument/2006/relationships/image" Target="../media/image28.emf"/><Relationship Id="rId12" Type="http://schemas.openxmlformats.org/officeDocument/2006/relationships/image" Target="../media/image31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7.emf"/><Relationship Id="rId11" Type="http://schemas.openxmlformats.org/officeDocument/2006/relationships/image" Target="../media/image23.emf"/><Relationship Id="rId5" Type="http://schemas.openxmlformats.org/officeDocument/2006/relationships/image" Target="../media/image26.emf"/><Relationship Id="rId10" Type="http://schemas.openxmlformats.org/officeDocument/2006/relationships/oleObject" Target="../embeddings/oleObject1.bin"/><Relationship Id="rId4" Type="http://schemas.openxmlformats.org/officeDocument/2006/relationships/image" Target="../media/image25.emf"/><Relationship Id="rId9" Type="http://schemas.openxmlformats.org/officeDocument/2006/relationships/image" Target="../media/image30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emf"/><Relationship Id="rId3" Type="http://schemas.openxmlformats.org/officeDocument/2006/relationships/image" Target="../media/image34.emf"/><Relationship Id="rId7" Type="http://schemas.openxmlformats.org/officeDocument/2006/relationships/image" Target="../media/image38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7.emf"/><Relationship Id="rId5" Type="http://schemas.openxmlformats.org/officeDocument/2006/relationships/image" Target="../media/image36.emf"/><Relationship Id="rId4" Type="http://schemas.openxmlformats.org/officeDocument/2006/relationships/image" Target="../media/image35.emf"/><Relationship Id="rId9" Type="http://schemas.openxmlformats.org/officeDocument/2006/relationships/image" Target="../media/image40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3" Type="http://schemas.openxmlformats.org/officeDocument/2006/relationships/image" Target="../media/image42.emf"/><Relationship Id="rId7" Type="http://schemas.openxmlformats.org/officeDocument/2006/relationships/image" Target="../media/image46.em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5.emf"/><Relationship Id="rId5" Type="http://schemas.openxmlformats.org/officeDocument/2006/relationships/image" Target="../media/image44.emf"/><Relationship Id="rId4" Type="http://schemas.openxmlformats.org/officeDocument/2006/relationships/image" Target="../media/image43.emf"/><Relationship Id="rId9" Type="http://schemas.openxmlformats.org/officeDocument/2006/relationships/image" Target="../media/image48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5" Type="http://schemas.openxmlformats.org/officeDocument/2006/relationships/image" Target="../media/image52.pn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Relationship Id="rId14" Type="http://schemas.openxmlformats.org/officeDocument/2006/relationships/image" Target="../media/image6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733101" y="-25594"/>
            <a:ext cx="1903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Table S1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38052" y="2426368"/>
            <a:ext cx="658189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Table S1: Formulation physical characteristics. </a:t>
            </a:r>
            <a:r>
              <a:rPr lang="en-US" sz="1400" dirty="0" smtClean="0"/>
              <a:t>Compounds were formulated in 2% glycerol in water. Final pH is given in the table above. Size (z-average) and </a:t>
            </a:r>
            <a:r>
              <a:rPr lang="en-US" sz="1400" dirty="0" err="1" smtClean="0"/>
              <a:t>polydispersity</a:t>
            </a:r>
            <a:r>
              <a:rPr lang="en-US" sz="1400" dirty="0" smtClean="0"/>
              <a:t> (PDI) were measured via dynamic light </a:t>
            </a:r>
            <a:r>
              <a:rPr lang="en-US" sz="1400" dirty="0"/>
              <a:t>scattering (Malvern </a:t>
            </a:r>
            <a:r>
              <a:rPr lang="en-US" sz="1400" dirty="0" err="1"/>
              <a:t>Zetasizer</a:t>
            </a:r>
            <a:r>
              <a:rPr lang="en-US" sz="1400" dirty="0"/>
              <a:t> Nano </a:t>
            </a:r>
            <a:r>
              <a:rPr lang="en-US" sz="1400" dirty="0" smtClean="0"/>
              <a:t>ZS).</a:t>
            </a:r>
            <a:endParaRPr lang="en-US" sz="14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3631" y="738690"/>
            <a:ext cx="6490739" cy="14066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5505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733101" y="-25594"/>
            <a:ext cx="1903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88521" y="6847812"/>
            <a:ext cx="646598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4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</a:t>
            </a:r>
            <a:r>
              <a:rPr lang="en-US" sz="14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vel </a:t>
            </a:r>
            <a:r>
              <a:rPr lang="en-US" sz="14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idazoquinolines</a:t>
            </a:r>
            <a:r>
              <a:rPr lang="en-US" sz="14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 TLR7/8 agonists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a) Activity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f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idazoquinoline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n human embryonic kidney (HEK) reporter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ull control cells lacking expression of human TLR7 or TLR8 and mouse TLR7 or TLR8. b) R848 +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lydT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hows activity in HEK cells expressing mouse TLR8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521" y="158745"/>
            <a:ext cx="4900283" cy="2911151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521" y="3180592"/>
            <a:ext cx="3772379" cy="291115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88521" y="207381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88521" y="315554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7984417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0"/>
          <p:cNvSpPr/>
          <p:nvPr/>
        </p:nvSpPr>
        <p:spPr>
          <a:xfrm>
            <a:off x="4933950" y="326827"/>
            <a:ext cx="752475" cy="2351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TextBox 6"/>
          <p:cNvSpPr txBox="1"/>
          <p:nvPr/>
        </p:nvSpPr>
        <p:spPr>
          <a:xfrm>
            <a:off x="5686425" y="5509260"/>
            <a:ext cx="1903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2</a:t>
            </a:r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/>
          <a:srcRect b="23188"/>
          <a:stretch/>
        </p:blipFill>
        <p:spPr>
          <a:xfrm>
            <a:off x="5418772" y="47626"/>
            <a:ext cx="1371600" cy="1333850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59242" y="1513657"/>
            <a:ext cx="1645920" cy="1620203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4"/>
          <a:srcRect b="21095"/>
          <a:stretch/>
        </p:blipFill>
        <p:spPr>
          <a:xfrm>
            <a:off x="5120640" y="1510799"/>
            <a:ext cx="1645920" cy="168021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5"/>
          <a:srcRect b="20817"/>
          <a:stretch/>
        </p:blipFill>
        <p:spPr>
          <a:xfrm>
            <a:off x="1566862" y="3346222"/>
            <a:ext cx="1645920" cy="168613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6"/>
          <a:srcRect b="21497"/>
          <a:stretch/>
        </p:blipFill>
        <p:spPr>
          <a:xfrm>
            <a:off x="5097780" y="3371850"/>
            <a:ext cx="1645920" cy="1671638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7"/>
          <a:srcRect b="21095"/>
          <a:stretch/>
        </p:blipFill>
        <p:spPr>
          <a:xfrm>
            <a:off x="3103958" y="5276850"/>
            <a:ext cx="1645920" cy="168021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8"/>
          <a:srcRect b="21312"/>
          <a:stretch/>
        </p:blipFill>
        <p:spPr>
          <a:xfrm>
            <a:off x="3103958" y="7206035"/>
            <a:ext cx="1645920" cy="1675589"/>
          </a:xfrm>
          <a:prstGeom prst="rect">
            <a:avLst/>
          </a:prstGeom>
        </p:spPr>
      </p:pic>
      <p:sp>
        <p:nvSpPr>
          <p:cNvPr id="26" name="Rectangle 25"/>
          <p:cNvSpPr/>
          <p:nvPr/>
        </p:nvSpPr>
        <p:spPr>
          <a:xfrm>
            <a:off x="1543050" y="1760220"/>
            <a:ext cx="133350" cy="9372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7150" y="1513657"/>
            <a:ext cx="1645920" cy="1620203"/>
          </a:xfrm>
          <a:prstGeom prst="rect">
            <a:avLst/>
          </a:prstGeom>
        </p:spPr>
      </p:pic>
      <p:sp>
        <p:nvSpPr>
          <p:cNvPr id="27" name="Rectangle 26"/>
          <p:cNvSpPr/>
          <p:nvPr/>
        </p:nvSpPr>
        <p:spPr>
          <a:xfrm>
            <a:off x="5104448" y="1714500"/>
            <a:ext cx="149954" cy="10134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10"/>
          <a:srcRect b="21497"/>
          <a:stretch/>
        </p:blipFill>
        <p:spPr>
          <a:xfrm>
            <a:off x="3595688" y="1513657"/>
            <a:ext cx="1645920" cy="1671638"/>
          </a:xfrm>
          <a:prstGeom prst="rect">
            <a:avLst/>
          </a:prstGeom>
        </p:spPr>
      </p:pic>
      <p:sp>
        <p:nvSpPr>
          <p:cNvPr id="28" name="Rectangle 27"/>
          <p:cNvSpPr/>
          <p:nvPr/>
        </p:nvSpPr>
        <p:spPr>
          <a:xfrm>
            <a:off x="1550670" y="3581400"/>
            <a:ext cx="110490" cy="9448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11"/>
          <a:srcRect b="21421"/>
          <a:stretch/>
        </p:blipFill>
        <p:spPr>
          <a:xfrm>
            <a:off x="57150" y="3360509"/>
            <a:ext cx="1645920" cy="1673272"/>
          </a:xfrm>
          <a:prstGeom prst="rect">
            <a:avLst/>
          </a:prstGeom>
        </p:spPr>
      </p:pic>
      <p:sp>
        <p:nvSpPr>
          <p:cNvPr id="29" name="Rectangle 28"/>
          <p:cNvSpPr/>
          <p:nvPr/>
        </p:nvSpPr>
        <p:spPr>
          <a:xfrm>
            <a:off x="5094382" y="3665220"/>
            <a:ext cx="125318" cy="8686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12"/>
          <a:srcRect b="21900"/>
          <a:stretch/>
        </p:blipFill>
        <p:spPr>
          <a:xfrm>
            <a:off x="3595688" y="3371851"/>
            <a:ext cx="1645920" cy="1663065"/>
          </a:xfrm>
          <a:prstGeom prst="rect">
            <a:avLst/>
          </a:prstGeom>
        </p:spPr>
      </p:pic>
      <p:sp>
        <p:nvSpPr>
          <p:cNvPr id="30" name="Rectangle 29"/>
          <p:cNvSpPr/>
          <p:nvPr/>
        </p:nvSpPr>
        <p:spPr>
          <a:xfrm>
            <a:off x="3121342" y="5509260"/>
            <a:ext cx="147638" cy="9829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13"/>
          <a:srcRect b="20693"/>
          <a:stretch/>
        </p:blipFill>
        <p:spPr>
          <a:xfrm>
            <a:off x="1582102" y="5286375"/>
            <a:ext cx="1645920" cy="1688783"/>
          </a:xfrm>
          <a:prstGeom prst="rect">
            <a:avLst/>
          </a:prstGeom>
        </p:spPr>
      </p:pic>
      <p:sp>
        <p:nvSpPr>
          <p:cNvPr id="31" name="Rectangle 30"/>
          <p:cNvSpPr/>
          <p:nvPr/>
        </p:nvSpPr>
        <p:spPr>
          <a:xfrm>
            <a:off x="1576626" y="5509260"/>
            <a:ext cx="122634" cy="98298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14"/>
          <a:srcRect b="21497"/>
          <a:stretch/>
        </p:blipFill>
        <p:spPr>
          <a:xfrm>
            <a:off x="67866" y="5286375"/>
            <a:ext cx="1645920" cy="1671638"/>
          </a:xfrm>
          <a:prstGeom prst="rect">
            <a:avLst/>
          </a:prstGeom>
        </p:spPr>
      </p:pic>
      <p:sp>
        <p:nvSpPr>
          <p:cNvPr id="32" name="Rectangle 31"/>
          <p:cNvSpPr/>
          <p:nvPr/>
        </p:nvSpPr>
        <p:spPr>
          <a:xfrm>
            <a:off x="3103958" y="7467600"/>
            <a:ext cx="101204" cy="8991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15"/>
          <a:srcRect b="21839"/>
          <a:stretch/>
        </p:blipFill>
        <p:spPr>
          <a:xfrm>
            <a:off x="1582102" y="7206035"/>
            <a:ext cx="1645920" cy="1664365"/>
          </a:xfrm>
          <a:prstGeom prst="rect">
            <a:avLst/>
          </a:prstGeom>
        </p:spPr>
      </p:pic>
      <p:sp>
        <p:nvSpPr>
          <p:cNvPr id="33" name="Rectangle 32"/>
          <p:cNvSpPr/>
          <p:nvPr/>
        </p:nvSpPr>
        <p:spPr>
          <a:xfrm>
            <a:off x="1576626" y="7467600"/>
            <a:ext cx="122634" cy="8991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16"/>
          <a:srcRect b="21235"/>
          <a:stretch/>
        </p:blipFill>
        <p:spPr>
          <a:xfrm>
            <a:off x="67866" y="7206035"/>
            <a:ext cx="1645920" cy="1677223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 rot="16200000">
            <a:off x="5119782" y="479563"/>
            <a:ext cx="737380" cy="1051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FSC-A</a:t>
            </a:r>
            <a:endParaRPr lang="en-US" sz="1000" b="1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17"/>
          <a:srcRect b="21256"/>
          <a:stretch/>
        </p:blipFill>
        <p:spPr>
          <a:xfrm>
            <a:off x="4069080" y="47626"/>
            <a:ext cx="1371600" cy="1397318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 rot="16200000">
            <a:off x="3772948" y="476128"/>
            <a:ext cx="73738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8</a:t>
            </a:r>
            <a:endParaRPr lang="en-US" sz="1000" b="1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18"/>
          <a:srcRect b="21981"/>
          <a:stretch/>
        </p:blipFill>
        <p:spPr>
          <a:xfrm>
            <a:off x="2694622" y="47626"/>
            <a:ext cx="1371600" cy="1367366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 rot="16200000">
            <a:off x="2400396" y="485031"/>
            <a:ext cx="73738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ount</a:t>
            </a:r>
            <a:endParaRPr lang="en-US" sz="10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19"/>
          <a:srcRect b="22464"/>
          <a:stretch/>
        </p:blipFill>
        <p:spPr>
          <a:xfrm>
            <a:off x="1352550" y="47626"/>
            <a:ext cx="1371600" cy="1346433"/>
          </a:xfrm>
          <a:prstGeom prst="rect">
            <a:avLst/>
          </a:prstGeom>
        </p:spPr>
      </p:pic>
      <p:sp>
        <p:nvSpPr>
          <p:cNvPr id="38" name="TextBox 37"/>
          <p:cNvSpPr txBox="1"/>
          <p:nvPr/>
        </p:nvSpPr>
        <p:spPr>
          <a:xfrm rot="16200000">
            <a:off x="1067659" y="485031"/>
            <a:ext cx="73738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SSC-A</a:t>
            </a:r>
            <a:endParaRPr lang="en-US" sz="10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0"/>
          <a:srcRect b="21497"/>
          <a:stretch/>
        </p:blipFill>
        <p:spPr>
          <a:xfrm>
            <a:off x="3810" y="47626"/>
            <a:ext cx="1371600" cy="1388692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 rot="16200000">
            <a:off x="-297472" y="479563"/>
            <a:ext cx="737380" cy="1051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ount</a:t>
            </a:r>
            <a:endParaRPr lang="en-US" sz="10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441960" y="1294462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Live/Dead</a:t>
            </a:r>
            <a:endParaRPr lang="en-US" sz="10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1870710" y="1294462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FSC-A</a:t>
            </a:r>
            <a:endParaRPr lang="en-US" sz="10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3189922" y="1294462"/>
            <a:ext cx="76962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3</a:t>
            </a:r>
            <a:endParaRPr lang="en-US" sz="1000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4485322" y="1294462"/>
            <a:ext cx="76962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4</a:t>
            </a:r>
            <a:endParaRPr lang="en-US" sz="1000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5928360" y="1294462"/>
            <a:ext cx="76962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FSC-H</a:t>
            </a:r>
            <a:endParaRPr lang="en-US" sz="1000" b="1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-445498" y="2068086"/>
            <a:ext cx="112680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4</a:t>
            </a:r>
            <a:endParaRPr lang="en-US" sz="10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559377" y="3047298"/>
            <a:ext cx="241539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err="1" smtClean="0"/>
              <a:t>IFNg</a:t>
            </a:r>
            <a:endParaRPr lang="en-US" sz="1000" b="1" dirty="0"/>
          </a:p>
        </p:txBody>
      </p:sp>
      <p:cxnSp>
        <p:nvCxnSpPr>
          <p:cNvPr id="48" name="Straight Arrow Connector 47"/>
          <p:cNvCxnSpPr>
            <a:endCxn id="46" idx="3"/>
          </p:cNvCxnSpPr>
          <p:nvPr/>
        </p:nvCxnSpPr>
        <p:spPr>
          <a:xfrm>
            <a:off x="853440" y="3124242"/>
            <a:ext cx="212133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 rot="16200000">
            <a:off x="3090927" y="2068086"/>
            <a:ext cx="112680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4</a:t>
            </a:r>
            <a:endParaRPr lang="en-US" sz="10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4113270" y="3031408"/>
            <a:ext cx="241539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17</a:t>
            </a:r>
            <a:endParaRPr lang="en-US" sz="1000" b="1" dirty="0"/>
          </a:p>
        </p:txBody>
      </p:sp>
      <p:cxnSp>
        <p:nvCxnSpPr>
          <p:cNvPr id="51" name="Straight Arrow Connector 50"/>
          <p:cNvCxnSpPr>
            <a:endCxn id="50" idx="3"/>
          </p:cNvCxnSpPr>
          <p:nvPr/>
        </p:nvCxnSpPr>
        <p:spPr>
          <a:xfrm>
            <a:off x="4407333" y="3108352"/>
            <a:ext cx="212133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 rot="16200000">
            <a:off x="-429306" y="3911894"/>
            <a:ext cx="112680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4</a:t>
            </a:r>
            <a:endParaRPr lang="en-US" sz="10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498769" y="4892751"/>
            <a:ext cx="241539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5</a:t>
            </a:r>
            <a:endParaRPr lang="en-US" sz="1000" b="1" dirty="0"/>
          </a:p>
        </p:txBody>
      </p:sp>
      <p:cxnSp>
        <p:nvCxnSpPr>
          <p:cNvPr id="54" name="Straight Arrow Connector 53"/>
          <p:cNvCxnSpPr>
            <a:endCxn id="53" idx="3"/>
          </p:cNvCxnSpPr>
          <p:nvPr/>
        </p:nvCxnSpPr>
        <p:spPr>
          <a:xfrm>
            <a:off x="792832" y="4969695"/>
            <a:ext cx="212133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4113270" y="4883719"/>
            <a:ext cx="241539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err="1" smtClean="0"/>
              <a:t>IFNg</a:t>
            </a:r>
            <a:endParaRPr lang="en-US" sz="1000" b="1" dirty="0"/>
          </a:p>
        </p:txBody>
      </p:sp>
      <p:cxnSp>
        <p:nvCxnSpPr>
          <p:cNvPr id="56" name="Straight Arrow Connector 55"/>
          <p:cNvCxnSpPr>
            <a:endCxn id="55" idx="3"/>
          </p:cNvCxnSpPr>
          <p:nvPr/>
        </p:nvCxnSpPr>
        <p:spPr>
          <a:xfrm>
            <a:off x="4407333" y="4960663"/>
            <a:ext cx="212133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 rot="16200000">
            <a:off x="3059702" y="3840221"/>
            <a:ext cx="112680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8</a:t>
            </a:r>
            <a:endParaRPr lang="en-US" sz="1000" b="1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-439300" y="5851896"/>
            <a:ext cx="1126800" cy="15388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4</a:t>
            </a:r>
            <a:endParaRPr lang="en-US" sz="10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2128259" y="8734413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2</a:t>
            </a:r>
            <a:endParaRPr lang="en-US" sz="10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2094071" y="6803172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2</a:t>
            </a:r>
            <a:endParaRPr lang="en-US" sz="1000" b="1" dirty="0"/>
          </a:p>
        </p:txBody>
      </p:sp>
      <p:sp>
        <p:nvSpPr>
          <p:cNvPr id="64" name="TextBox 63"/>
          <p:cNvSpPr txBox="1"/>
          <p:nvPr/>
        </p:nvSpPr>
        <p:spPr>
          <a:xfrm>
            <a:off x="3728460" y="8734413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err="1" smtClean="0"/>
              <a:t>TNFa</a:t>
            </a:r>
            <a:endParaRPr lang="en-US" sz="1000" b="1" dirty="0"/>
          </a:p>
        </p:txBody>
      </p:sp>
      <p:sp>
        <p:nvSpPr>
          <p:cNvPr id="65" name="TextBox 64"/>
          <p:cNvSpPr txBox="1"/>
          <p:nvPr/>
        </p:nvSpPr>
        <p:spPr>
          <a:xfrm>
            <a:off x="598219" y="8727736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err="1" smtClean="0"/>
              <a:t>IFNg</a:t>
            </a:r>
            <a:endParaRPr lang="en-US" sz="10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3636814" y="6812221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err="1" smtClean="0"/>
              <a:t>TNFa</a:t>
            </a:r>
            <a:endParaRPr lang="en-US" sz="1000" b="1" dirty="0"/>
          </a:p>
        </p:txBody>
      </p:sp>
      <p:sp>
        <p:nvSpPr>
          <p:cNvPr id="67" name="TextBox 66"/>
          <p:cNvSpPr txBox="1"/>
          <p:nvPr/>
        </p:nvSpPr>
        <p:spPr>
          <a:xfrm>
            <a:off x="608086" y="6803172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err="1" smtClean="0"/>
              <a:t>IFNg</a:t>
            </a:r>
            <a:endParaRPr lang="en-US" sz="1000" b="1" dirty="0"/>
          </a:p>
        </p:txBody>
      </p:sp>
      <p:sp>
        <p:nvSpPr>
          <p:cNvPr id="68" name="Rectangle 67"/>
          <p:cNvSpPr/>
          <p:nvPr/>
        </p:nvSpPr>
        <p:spPr>
          <a:xfrm>
            <a:off x="441960" y="1600780"/>
            <a:ext cx="411480" cy="1098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Rectangle 68"/>
          <p:cNvSpPr/>
          <p:nvPr/>
        </p:nvSpPr>
        <p:spPr>
          <a:xfrm>
            <a:off x="1937995" y="1600780"/>
            <a:ext cx="497891" cy="1098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/>
          <p:cNvSpPr/>
          <p:nvPr/>
        </p:nvSpPr>
        <p:spPr>
          <a:xfrm>
            <a:off x="429166" y="1679227"/>
            <a:ext cx="178920" cy="2029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/>
          <p:cNvSpPr/>
          <p:nvPr/>
        </p:nvSpPr>
        <p:spPr>
          <a:xfrm>
            <a:off x="1966511" y="1655685"/>
            <a:ext cx="178920" cy="20291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TextBox 71"/>
          <p:cNvSpPr txBox="1"/>
          <p:nvPr/>
        </p:nvSpPr>
        <p:spPr>
          <a:xfrm>
            <a:off x="-32139" y="-67734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-32139" y="1397001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3483054" y="1418619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-32139" y="3233629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478974" y="3255230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-32139" y="5132290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-32139" y="7098268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600447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5757" y="245307"/>
            <a:ext cx="646598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Example gating demonstrating how cytokine positive cells were determined. a) Gating strategy to identify live, CD4+ CD8- or CD4- CD8+ singlet T cells.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-e)T cell cytokine production from mice vaccinated with A/Vic alone (left plot) compared to mice vaccinated with A/Vic plus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pidated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LR7/8 agonist (right plot),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)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lyfunctional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D4 T cells from mice vaccinated with A/Vic alone,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)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lyfunctional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D4 T cell cytokine production from mice vaccinated with A/Vic plus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pidated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LR7/8 agonist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04698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88757" y="-39562"/>
            <a:ext cx="2743200" cy="2293542"/>
          </a:xfrm>
          <a:prstGeom prst="rect">
            <a:avLst/>
          </a:prstGeom>
        </p:spPr>
      </p:pic>
      <p:sp>
        <p:nvSpPr>
          <p:cNvPr id="23" name="Rectangle 22"/>
          <p:cNvSpPr/>
          <p:nvPr/>
        </p:nvSpPr>
        <p:spPr>
          <a:xfrm>
            <a:off x="3704595" y="1643062"/>
            <a:ext cx="2169065" cy="60987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92593" y="1646492"/>
            <a:ext cx="2743200" cy="2321122"/>
          </a:xfrm>
          <a:prstGeom prst="rect">
            <a:avLst/>
          </a:prstGeom>
        </p:spPr>
      </p:pic>
      <p:sp>
        <p:nvSpPr>
          <p:cNvPr id="24" name="Rectangle 23"/>
          <p:cNvSpPr/>
          <p:nvPr/>
        </p:nvSpPr>
        <p:spPr>
          <a:xfrm>
            <a:off x="3565530" y="3337986"/>
            <a:ext cx="2294576" cy="53430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276778" y="3345701"/>
            <a:ext cx="2743200" cy="2246983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5733101" y="-25594"/>
            <a:ext cx="1903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ure S3</a:t>
            </a:r>
            <a:endParaRPr lang="en-US" dirty="0"/>
          </a:p>
        </p:txBody>
      </p:sp>
      <p:sp>
        <p:nvSpPr>
          <p:cNvPr id="27" name="TextBox 26"/>
          <p:cNvSpPr txBox="1"/>
          <p:nvPr/>
        </p:nvSpPr>
        <p:spPr>
          <a:xfrm>
            <a:off x="77928" y="-67736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77928" y="1642536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77928" y="3223530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7928" y="4922391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7928" y="6661949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073400" y="0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073400" y="1572831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073400" y="5063092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4"/>
          <p:cNvSpPr/>
          <p:nvPr/>
        </p:nvSpPr>
        <p:spPr>
          <a:xfrm>
            <a:off x="3565530" y="4940457"/>
            <a:ext cx="2294576" cy="64570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5868" y="-83297"/>
            <a:ext cx="2743200" cy="245312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389895" y="1636714"/>
            <a:ext cx="2417000" cy="7757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117" y="1602694"/>
            <a:ext cx="2743200" cy="2395089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389895" y="3263054"/>
            <a:ext cx="2548890" cy="7658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1497" y="3220671"/>
            <a:ext cx="2743200" cy="2447728"/>
          </a:xfrm>
          <a:prstGeom prst="rect">
            <a:avLst/>
          </a:prstGeom>
        </p:spPr>
      </p:pic>
      <p:sp>
        <p:nvSpPr>
          <p:cNvPr id="15" name="Rectangle 14"/>
          <p:cNvSpPr/>
          <p:nvPr/>
        </p:nvSpPr>
        <p:spPr>
          <a:xfrm>
            <a:off x="389895" y="4949190"/>
            <a:ext cx="2417000" cy="7192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5" name="Picture 3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7401" y="4937716"/>
            <a:ext cx="2743200" cy="2453120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389895" y="6657778"/>
            <a:ext cx="2451290" cy="78831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109470" y="6709120"/>
          <a:ext cx="2743200" cy="23659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3" name="Prism 7" r:id="rId10" imgW="3451602" imgH="2976163" progId="Prism7.Document">
                  <p:embed/>
                </p:oleObj>
              </mc:Choice>
              <mc:Fallback>
                <p:oleObj name="Prism 7" r:id="rId10" imgW="3451602" imgH="2976163" progId="Prism7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09470" y="6709120"/>
                        <a:ext cx="2743200" cy="23659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9" name="TextBox 38"/>
          <p:cNvSpPr txBox="1"/>
          <p:nvPr/>
        </p:nvSpPr>
        <p:spPr>
          <a:xfrm>
            <a:off x="3073400" y="3393010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341218" y="4995418"/>
            <a:ext cx="2743200" cy="2270963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>
            <a:off x="3073400" y="6797247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3446467" y="6667937"/>
            <a:ext cx="2438903" cy="62813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314218" y="6758588"/>
            <a:ext cx="2926080" cy="23431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28493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5757" y="245307"/>
            <a:ext cx="6465980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/Vic-specific T cell responses from mice vaccinated with A/Vic plus low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ose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LR4 and/or TLR7/8 adjuvants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0.1 µg/mouse TLR4 agonist, 1 µg/mouse TLR7/8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gonist) as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termined by intracellular cytokine staining and flow cytometry (left column, a, c, e, g, and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nd secreted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yotkine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s measured by MSD assay (left column, b, d, f, h, and j).</a:t>
            </a:r>
          </a:p>
        </p:txBody>
      </p:sp>
    </p:spTree>
    <p:extLst>
      <p:ext uri="{BB962C8B-B14F-4D97-AF65-F5344CB8AC3E}">
        <p14:creationId xmlns:p14="http://schemas.microsoft.com/office/powerpoint/2010/main" val="392978334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64833" y="2410656"/>
            <a:ext cx="2286000" cy="2176418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83598" y="2587220"/>
            <a:ext cx="2286000" cy="1990992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48398" y="2611498"/>
            <a:ext cx="2286000" cy="1975576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64833" y="122119"/>
            <a:ext cx="2286000" cy="2226319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48398" y="329347"/>
            <a:ext cx="2286000" cy="2019091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376229" y="-78171"/>
            <a:ext cx="1903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. S4</a:t>
            </a:r>
          </a:p>
        </p:txBody>
      </p:sp>
      <p:sp>
        <p:nvSpPr>
          <p:cNvPr id="7" name="Rectangle 6"/>
          <p:cNvSpPr/>
          <p:nvPr/>
        </p:nvSpPr>
        <p:spPr>
          <a:xfrm>
            <a:off x="3341" y="6973051"/>
            <a:ext cx="646598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4. Replication of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dp2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 cell data from first in vivo study. Mice were vaccinated, bled, and spleens harvested and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timulated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ith A/Vic as described for Fig. 3 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725" y="76200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279994" y="76200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617073" y="76200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725" y="2462217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155917" y="2462217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541256" y="2462217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725" y="4544152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249050" y="4544152"/>
            <a:ext cx="3156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55256" y="513789"/>
            <a:ext cx="2286000" cy="1834649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52" y="4572140"/>
            <a:ext cx="2357750" cy="1937979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308850" y="4673078"/>
            <a:ext cx="2357749" cy="18370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90781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359548" y="530352"/>
            <a:ext cx="307298" cy="891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130956" y="155798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30956" y="2094755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2"/>
          <a:srcRect l="5050" r="37608"/>
          <a:stretch/>
        </p:blipFill>
        <p:spPr>
          <a:xfrm>
            <a:off x="3380182" y="183581"/>
            <a:ext cx="2869021" cy="231886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3"/>
          <a:srcRect l="5797" r="37623"/>
          <a:stretch/>
        </p:blipFill>
        <p:spPr>
          <a:xfrm>
            <a:off x="3423572" y="2010894"/>
            <a:ext cx="2941286" cy="2406137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4"/>
          <a:srcRect r="37769"/>
          <a:stretch/>
        </p:blipFill>
        <p:spPr>
          <a:xfrm>
            <a:off x="296673" y="3723160"/>
            <a:ext cx="2941286" cy="2521113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130956" y="3961212"/>
            <a:ext cx="476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5"/>
          <a:srcRect l="5564" r="38212"/>
          <a:stretch/>
        </p:blipFill>
        <p:spPr>
          <a:xfrm>
            <a:off x="3521853" y="4004384"/>
            <a:ext cx="2622915" cy="2159275"/>
          </a:xfrm>
          <a:prstGeom prst="rect">
            <a:avLst/>
          </a:prstGeom>
        </p:spPr>
      </p:pic>
      <p:sp>
        <p:nvSpPr>
          <p:cNvPr id="14" name="TextBox 13"/>
          <p:cNvSpPr txBox="1"/>
          <p:nvPr/>
        </p:nvSpPr>
        <p:spPr>
          <a:xfrm>
            <a:off x="6168530" y="-25594"/>
            <a:ext cx="1903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. S5</a:t>
            </a:r>
          </a:p>
        </p:txBody>
      </p:sp>
      <p:sp>
        <p:nvSpPr>
          <p:cNvPr id="15" name="Rectangle 14"/>
          <p:cNvSpPr/>
          <p:nvPr/>
        </p:nvSpPr>
        <p:spPr>
          <a:xfrm>
            <a:off x="0" y="6572382"/>
            <a:ext cx="646598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5.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PBMC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ection of IL-6 (a), IFN</a:t>
            </a:r>
            <a:r>
              <a:rPr lang="el-GR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b), and TNF</a:t>
            </a:r>
            <a:r>
              <a:rPr lang="el-GR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) as measured by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uminex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PBMCs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stimulated with indicated concentrations of compounds for 24 hours, after which supernatants were harvested and analyzed using the </a:t>
            </a:r>
            <a:r>
              <a:rPr lang="en-US" sz="14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uminex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platform.</a:t>
            </a:r>
            <a:endParaRPr lang="en-US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6"/>
          <a:srcRect r="36754"/>
          <a:stretch/>
        </p:blipFill>
        <p:spPr>
          <a:xfrm>
            <a:off x="151343" y="166235"/>
            <a:ext cx="3236576" cy="234686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7"/>
          <a:srcRect r="37666"/>
          <a:stretch/>
        </p:blipFill>
        <p:spPr>
          <a:xfrm>
            <a:off x="169723" y="1727798"/>
            <a:ext cx="3179772" cy="2753509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8"/>
          <a:srcRect l="66443" t="4523" r="2196" b="62819"/>
          <a:stretch/>
        </p:blipFill>
        <p:spPr>
          <a:xfrm>
            <a:off x="909315" y="377624"/>
            <a:ext cx="1224769" cy="618161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9"/>
          <a:srcRect l="66655" t="34533" r="2094" b="11350"/>
          <a:stretch/>
        </p:blipFill>
        <p:spPr>
          <a:xfrm>
            <a:off x="3897006" y="319349"/>
            <a:ext cx="1208323" cy="9828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82292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6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4437" y="4086402"/>
            <a:ext cx="1828800" cy="2315362"/>
          </a:xfrm>
          <a:prstGeom prst="rect">
            <a:avLst/>
          </a:prstGeom>
        </p:spPr>
      </p:pic>
      <p:pic>
        <p:nvPicPr>
          <p:cNvPr id="63" name="Picture 6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76027" y="4086402"/>
            <a:ext cx="1828800" cy="2315362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68240" y="4086402"/>
            <a:ext cx="1828800" cy="2315362"/>
          </a:xfrm>
          <a:prstGeom prst="rect">
            <a:avLst/>
          </a:prstGeom>
        </p:spPr>
      </p:pic>
      <p:pic>
        <p:nvPicPr>
          <p:cNvPr id="59" name="Picture 5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39405" y="1970655"/>
            <a:ext cx="1828800" cy="176168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168530" y="-71314"/>
            <a:ext cx="19037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. S6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6"/>
          <a:srcRect b="20988"/>
          <a:stretch/>
        </p:blipFill>
        <p:spPr>
          <a:xfrm>
            <a:off x="1348740" y="297180"/>
            <a:ext cx="1371600" cy="14020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7"/>
          <a:srcRect b="21453"/>
          <a:stretch/>
        </p:blipFill>
        <p:spPr>
          <a:xfrm>
            <a:off x="2720340" y="297181"/>
            <a:ext cx="1371600" cy="136398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8"/>
          <a:srcRect b="21417"/>
          <a:stretch/>
        </p:blipFill>
        <p:spPr>
          <a:xfrm>
            <a:off x="4089082" y="297180"/>
            <a:ext cx="1371600" cy="139446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9"/>
          <a:srcRect b="21417"/>
          <a:stretch/>
        </p:blipFill>
        <p:spPr>
          <a:xfrm>
            <a:off x="5460276" y="297180"/>
            <a:ext cx="1371600" cy="1394460"/>
          </a:xfrm>
          <a:prstGeom prst="rect">
            <a:avLst/>
          </a:prstGeom>
        </p:spPr>
      </p:pic>
      <p:cxnSp>
        <p:nvCxnSpPr>
          <p:cNvPr id="23" name="Straight Arrow Connector 22"/>
          <p:cNvCxnSpPr/>
          <p:nvPr/>
        </p:nvCxnSpPr>
        <p:spPr>
          <a:xfrm flipV="1">
            <a:off x="4796930" y="960120"/>
            <a:ext cx="1085710" cy="39624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3263153" y="1521519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FSC-H</a:t>
            </a:r>
            <a:endParaRPr lang="en-US" sz="1000" b="1" dirty="0"/>
          </a:p>
        </p:txBody>
      </p:sp>
      <p:sp>
        <p:nvSpPr>
          <p:cNvPr id="28" name="TextBox 27"/>
          <p:cNvSpPr txBox="1"/>
          <p:nvPr/>
        </p:nvSpPr>
        <p:spPr>
          <a:xfrm rot="16200000">
            <a:off x="2415136" y="802322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FSC-A</a:t>
            </a:r>
            <a:endParaRPr lang="en-US" sz="1000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1689568" y="1545373"/>
            <a:ext cx="10283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Lineage/Viability</a:t>
            </a:r>
            <a:endParaRPr lang="en-US" sz="1000" b="1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1065234" y="819361"/>
            <a:ext cx="699655" cy="10510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HLA-DR</a:t>
            </a:r>
            <a:endParaRPr lang="en-US" sz="10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10"/>
          <a:srcRect b="22331"/>
          <a:stretch/>
        </p:blipFill>
        <p:spPr>
          <a:xfrm>
            <a:off x="0" y="297181"/>
            <a:ext cx="1371600" cy="1348740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502437" y="1528683"/>
            <a:ext cx="769620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FSC-A</a:t>
            </a:r>
            <a:endParaRPr lang="en-US" sz="1000" b="1" dirty="0"/>
          </a:p>
        </p:txBody>
      </p:sp>
      <p:sp>
        <p:nvSpPr>
          <p:cNvPr id="41" name="TextBox 40"/>
          <p:cNvSpPr txBox="1"/>
          <p:nvPr/>
        </p:nvSpPr>
        <p:spPr>
          <a:xfrm rot="16200000">
            <a:off x="-260510" y="717253"/>
            <a:ext cx="699655" cy="13989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SSC-A</a:t>
            </a:r>
            <a:endParaRPr lang="en-US" sz="1000" b="1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3782586" y="739270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14</a:t>
            </a:r>
            <a:endParaRPr lang="en-US" sz="1000" b="1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5150922" y="759988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123</a:t>
            </a:r>
            <a:endParaRPr lang="en-US" sz="10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4482299" y="1537752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16</a:t>
            </a:r>
            <a:endParaRPr lang="en-US" sz="10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5862367" y="1554683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CD11c</a:t>
            </a:r>
            <a:endParaRPr lang="en-US" sz="1000" b="1" dirty="0"/>
          </a:p>
        </p:txBody>
      </p:sp>
      <p:sp>
        <p:nvSpPr>
          <p:cNvPr id="20" name="Rectangle 19"/>
          <p:cNvSpPr/>
          <p:nvPr/>
        </p:nvSpPr>
        <p:spPr>
          <a:xfrm>
            <a:off x="1716405" y="2302595"/>
            <a:ext cx="70612" cy="452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/>
          <p:cNvSpPr/>
          <p:nvPr/>
        </p:nvSpPr>
        <p:spPr>
          <a:xfrm>
            <a:off x="1665602" y="3855965"/>
            <a:ext cx="70612" cy="452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/>
          <p:cNvSpPr/>
          <p:nvPr/>
        </p:nvSpPr>
        <p:spPr>
          <a:xfrm>
            <a:off x="1640198" y="4565133"/>
            <a:ext cx="70612" cy="452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/>
          <p:cNvSpPr/>
          <p:nvPr/>
        </p:nvSpPr>
        <p:spPr>
          <a:xfrm>
            <a:off x="3291200" y="4632866"/>
            <a:ext cx="70612" cy="452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/>
          <p:cNvSpPr/>
          <p:nvPr/>
        </p:nvSpPr>
        <p:spPr>
          <a:xfrm>
            <a:off x="3333534" y="3388265"/>
            <a:ext cx="70612" cy="452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Rectangle 51"/>
          <p:cNvSpPr/>
          <p:nvPr/>
        </p:nvSpPr>
        <p:spPr>
          <a:xfrm>
            <a:off x="3350465" y="2133261"/>
            <a:ext cx="70612" cy="452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/>
          <p:cNvSpPr/>
          <p:nvPr/>
        </p:nvSpPr>
        <p:spPr>
          <a:xfrm>
            <a:off x="4967604" y="4649799"/>
            <a:ext cx="70612" cy="452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ctangle 53"/>
          <p:cNvSpPr/>
          <p:nvPr/>
        </p:nvSpPr>
        <p:spPr>
          <a:xfrm>
            <a:off x="4984537" y="3405198"/>
            <a:ext cx="70612" cy="452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ctangle 54"/>
          <p:cNvSpPr/>
          <p:nvPr/>
        </p:nvSpPr>
        <p:spPr>
          <a:xfrm>
            <a:off x="5001468" y="2285661"/>
            <a:ext cx="70612" cy="4523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353568" y="1700886"/>
            <a:ext cx="378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CD14+CD16- monocytes, vehicle control</a:t>
            </a:r>
            <a:endParaRPr lang="en-US" sz="1600" dirty="0"/>
          </a:p>
        </p:txBody>
      </p:sp>
      <p:sp>
        <p:nvSpPr>
          <p:cNvPr id="60" name="TextBox 59"/>
          <p:cNvSpPr txBox="1"/>
          <p:nvPr/>
        </p:nvSpPr>
        <p:spPr>
          <a:xfrm>
            <a:off x="340881" y="3795309"/>
            <a:ext cx="42792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CD14+CD16- monocytes, UM-3005 stimulation</a:t>
            </a:r>
            <a:endParaRPr lang="en-US" sz="1600" dirty="0"/>
          </a:p>
        </p:txBody>
      </p:sp>
      <p:pic>
        <p:nvPicPr>
          <p:cNvPr id="58" name="Picture 57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325335" y="1970655"/>
            <a:ext cx="1828800" cy="1761688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58580" y="1970655"/>
            <a:ext cx="1828800" cy="1761688"/>
          </a:xfrm>
          <a:prstGeom prst="rect">
            <a:avLst/>
          </a:prstGeom>
        </p:spPr>
      </p:pic>
      <p:pic>
        <p:nvPicPr>
          <p:cNvPr id="56" name="Picture 55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337" y="1970655"/>
            <a:ext cx="1828800" cy="1761688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668866" y="3634613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LAP (TGF</a:t>
            </a:r>
            <a:r>
              <a:rPr lang="el-GR" sz="1000" b="1" dirty="0" smtClean="0"/>
              <a:t>β</a:t>
            </a:r>
            <a:r>
              <a:rPr lang="en-US" sz="1000" b="1" dirty="0" smtClean="0"/>
              <a:t>)</a:t>
            </a:r>
            <a:endParaRPr lang="en-US" sz="10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2442254" y="3637854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-4</a:t>
            </a:r>
            <a:endParaRPr lang="en-US" sz="10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4173688" y="3624667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-6</a:t>
            </a:r>
            <a:endParaRPr lang="en-US" sz="10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5656579" y="3624667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-12/23</a:t>
            </a:r>
            <a:endParaRPr lang="en-US" sz="1000" b="1" dirty="0"/>
          </a:p>
        </p:txBody>
      </p:sp>
      <p:sp>
        <p:nvSpPr>
          <p:cNvPr id="22" name="TextBox 21"/>
          <p:cNvSpPr txBox="1"/>
          <p:nvPr/>
        </p:nvSpPr>
        <p:spPr>
          <a:xfrm rot="16200000">
            <a:off x="-287026" y="2547962"/>
            <a:ext cx="769620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FSC-A</a:t>
            </a:r>
            <a:endParaRPr lang="en-US" sz="1000" b="1" dirty="0"/>
          </a:p>
        </p:txBody>
      </p:sp>
      <p:pic>
        <p:nvPicPr>
          <p:cNvPr id="61" name="Picture 60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-27153" y="4086402"/>
            <a:ext cx="1828800" cy="2315361"/>
          </a:xfrm>
          <a:prstGeom prst="rect">
            <a:avLst/>
          </a:prstGeom>
        </p:spPr>
      </p:pic>
      <p:sp>
        <p:nvSpPr>
          <p:cNvPr id="65" name="Rectangle 64"/>
          <p:cNvSpPr/>
          <p:nvPr/>
        </p:nvSpPr>
        <p:spPr>
          <a:xfrm>
            <a:off x="190889" y="6463695"/>
            <a:ext cx="6577316" cy="6434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706923" y="5754056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LAP (TGF</a:t>
            </a:r>
            <a:r>
              <a:rPr lang="el-GR" sz="1000" b="1" dirty="0" smtClean="0"/>
              <a:t>β</a:t>
            </a:r>
            <a:r>
              <a:rPr lang="en-US" sz="1000" b="1" dirty="0" smtClean="0"/>
              <a:t>)</a:t>
            </a:r>
            <a:endParaRPr lang="en-US" sz="10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2410928" y="5754056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-4</a:t>
            </a:r>
            <a:endParaRPr lang="en-US" sz="10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4072088" y="5748342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-6</a:t>
            </a:r>
            <a:endParaRPr lang="en-US" sz="10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5834380" y="5748342"/>
            <a:ext cx="76962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IL-12/23</a:t>
            </a:r>
            <a:endParaRPr lang="en-US" sz="1000" b="1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-303961" y="4645179"/>
            <a:ext cx="769620" cy="169277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000" b="1" dirty="0" smtClean="0"/>
              <a:t>FSC-A</a:t>
            </a:r>
            <a:endParaRPr lang="en-US" sz="1000" b="1" dirty="0"/>
          </a:p>
        </p:txBody>
      </p:sp>
      <p:sp>
        <p:nvSpPr>
          <p:cNvPr id="66" name="Rectangle 65"/>
          <p:cNvSpPr/>
          <p:nvPr/>
        </p:nvSpPr>
        <p:spPr>
          <a:xfrm>
            <a:off x="92345" y="7725277"/>
            <a:ext cx="646598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4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6. 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xample flow gating demonstrating gating strategy to distinguish monocytes,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DC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and </a:t>
            </a:r>
            <a:r>
              <a:rPr lang="en-US" sz="14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DCs</a:t>
            </a:r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rom healthy human PBMCs (top row). Example intracellular cytokine staining from vehicle control monocytes (middle row), and UM-3005 stimulated monocytes (bottom row).</a:t>
            </a:r>
          </a:p>
        </p:txBody>
      </p:sp>
      <p:sp>
        <p:nvSpPr>
          <p:cNvPr id="8" name="Rectangle 7"/>
          <p:cNvSpPr/>
          <p:nvPr/>
        </p:nvSpPr>
        <p:spPr>
          <a:xfrm>
            <a:off x="340881" y="6047232"/>
            <a:ext cx="5827649" cy="41646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09355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72</TotalTime>
  <Words>506</Words>
  <Application>Microsoft Office PowerPoint</Application>
  <PresentationFormat>Letter Paper (8.5x11 in)</PresentationFormat>
  <Paragraphs>91</Paragraphs>
  <Slides>9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ller, Shannon</dc:creator>
  <cp:lastModifiedBy>Miller, Shannon</cp:lastModifiedBy>
  <cp:revision>20</cp:revision>
  <dcterms:created xsi:type="dcterms:W3CDTF">2019-07-13T17:56:05Z</dcterms:created>
  <dcterms:modified xsi:type="dcterms:W3CDTF">2020-02-17T18:19:18Z</dcterms:modified>
</cp:coreProperties>
</file>